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726"/>
  </p:normalViewPr>
  <p:slideViewPr>
    <p:cSldViewPr snapToGrid="0">
      <p:cViewPr>
        <p:scale>
          <a:sx n="154" d="100"/>
          <a:sy n="154" d="100"/>
        </p:scale>
        <p:origin x="1648" y="-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183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073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96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547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067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614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428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711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340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338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554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396D1-4F77-C24A-B608-AAFE305E7AFA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9204E-BFF9-1742-8E2F-076862BA3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687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718900EB-4880-1E9C-6EA0-05CDE8FFA5B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1533"/>
          <a:stretch>
            <a:fillRect/>
          </a:stretch>
        </p:blipFill>
        <p:spPr>
          <a:xfrm>
            <a:off x="292829" y="1817485"/>
            <a:ext cx="3514462" cy="1533107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EB31B878-4E84-E245-91A8-19E166D179C0}"/>
              </a:ext>
            </a:extLst>
          </p:cNvPr>
          <p:cNvGrpSpPr/>
          <p:nvPr/>
        </p:nvGrpSpPr>
        <p:grpSpPr>
          <a:xfrm>
            <a:off x="352243" y="235155"/>
            <a:ext cx="2489262" cy="1305756"/>
            <a:chOff x="335707" y="1701245"/>
            <a:chExt cx="2489262" cy="1305756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B3F3450-E3CD-E43B-2925-12CB509D2EBD}"/>
                </a:ext>
              </a:extLst>
            </p:cNvPr>
            <p:cNvGrpSpPr/>
            <p:nvPr/>
          </p:nvGrpSpPr>
          <p:grpSpPr>
            <a:xfrm>
              <a:off x="335707" y="1701245"/>
              <a:ext cx="2489262" cy="1305756"/>
              <a:chOff x="174075" y="1644729"/>
              <a:chExt cx="2051015" cy="1161397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31144199-83B9-DB5B-F72B-A86FED717BAA}"/>
                  </a:ext>
                </a:extLst>
              </p:cNvPr>
              <p:cNvGrpSpPr/>
              <p:nvPr/>
            </p:nvGrpSpPr>
            <p:grpSpPr>
              <a:xfrm>
                <a:off x="174075" y="1644729"/>
                <a:ext cx="1703541" cy="1161397"/>
                <a:chOff x="719979" y="1334874"/>
                <a:chExt cx="1817798" cy="1204261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92AB6705-9AC0-C36E-FAC7-845AFA2B7380}"/>
                    </a:ext>
                  </a:extLst>
                </p:cNvPr>
                <p:cNvGrpSpPr/>
                <p:nvPr/>
              </p:nvGrpSpPr>
              <p:grpSpPr>
                <a:xfrm>
                  <a:off x="719979" y="1897254"/>
                  <a:ext cx="1817798" cy="641881"/>
                  <a:chOff x="5354351" y="830454"/>
                  <a:chExt cx="1817798" cy="641881"/>
                </a:xfrm>
              </p:grpSpPr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A4026E09-01A9-3C73-2B9D-76B657ECF17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636" t="33683" r="44824" b="51183"/>
                  <a:stretch/>
                </p:blipFill>
                <p:spPr>
                  <a:xfrm>
                    <a:off x="5512763" y="830454"/>
                    <a:ext cx="1659386" cy="641881"/>
                  </a:xfrm>
                  <a:prstGeom prst="rect">
                    <a:avLst/>
                  </a:prstGeom>
                </p:spPr>
              </p:pic>
              <p:sp>
                <p:nvSpPr>
                  <p:cNvPr id="14" name="Rectangle 13">
                    <a:extLst>
                      <a:ext uri="{FF2B5EF4-FFF2-40B4-BE49-F238E27FC236}">
                        <a16:creationId xmlns:a16="http://schemas.microsoft.com/office/drawing/2014/main" id="{63EA2346-31AB-DE8C-8578-81FD2E866791}"/>
                      </a:ext>
                    </a:extLst>
                  </p:cNvPr>
                  <p:cNvSpPr/>
                  <p:nvPr/>
                </p:nvSpPr>
                <p:spPr>
                  <a:xfrm>
                    <a:off x="5354351" y="856950"/>
                    <a:ext cx="438707" cy="34062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91-</a:t>
                    </a:r>
                  </a:p>
                  <a:p>
                    <a:endParaRPr lang="en-US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r>
                      <a:rPr 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1-</a:t>
                    </a:r>
                  </a:p>
                </p:txBody>
              </p:sp>
              <p:sp>
                <p:nvSpPr>
                  <p:cNvPr id="15" name="Rectangle 14">
                    <a:extLst>
                      <a:ext uri="{FF2B5EF4-FFF2-40B4-BE49-F238E27FC236}">
                        <a16:creationId xmlns:a16="http://schemas.microsoft.com/office/drawing/2014/main" id="{A2EE67CC-784F-3EF1-39AB-90DBA93888A5}"/>
                      </a:ext>
                    </a:extLst>
                  </p:cNvPr>
                  <p:cNvSpPr/>
                  <p:nvPr/>
                </p:nvSpPr>
                <p:spPr>
                  <a:xfrm>
                    <a:off x="5359666" y="1245098"/>
                    <a:ext cx="438706" cy="170312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1-</a:t>
                    </a:r>
                  </a:p>
                </p:txBody>
              </p:sp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FFC95044-D8F8-D4A5-F8B0-B3358EDD9F51}"/>
                    </a:ext>
                  </a:extLst>
                </p:cNvPr>
                <p:cNvSpPr txBox="1"/>
                <p:nvPr/>
              </p:nvSpPr>
              <p:spPr>
                <a:xfrm rot="16200000">
                  <a:off x="952721" y="1594868"/>
                  <a:ext cx="571396" cy="1894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UNO</a:t>
                  </a:r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6FEEE507-E566-1B03-F28A-00E340482416}"/>
                    </a:ext>
                  </a:extLst>
                </p:cNvPr>
                <p:cNvSpPr txBox="1"/>
                <p:nvPr/>
              </p:nvSpPr>
              <p:spPr>
                <a:xfrm rot="16200000">
                  <a:off x="1302547" y="1542385"/>
                  <a:ext cx="604441" cy="1894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sP1 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B3052791-7105-3ABF-7985-14871EFD8408}"/>
                    </a:ext>
                  </a:extLst>
                </p:cNvPr>
                <p:cNvSpPr txBox="1"/>
                <p:nvPr/>
              </p:nvSpPr>
              <p:spPr>
                <a:xfrm rot="16200000">
                  <a:off x="1725018" y="1588794"/>
                  <a:ext cx="527081" cy="1894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sP2 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707BB450-ABAD-8712-13BC-14B6335A0164}"/>
                    </a:ext>
                  </a:extLst>
                </p:cNvPr>
                <p:cNvSpPr txBox="1"/>
                <p:nvPr/>
              </p:nvSpPr>
              <p:spPr>
                <a:xfrm rot="16200000">
                  <a:off x="2056442" y="1629513"/>
                  <a:ext cx="482738" cy="1894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sP3 </a:t>
                  </a:r>
                </a:p>
              </p:txBody>
            </p:sp>
          </p:grp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E159118D-EC55-120E-936B-BB8DE86F1C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47811" t="37307" r="47961" b="50447"/>
              <a:stretch/>
            </p:blipFill>
            <p:spPr>
              <a:xfrm>
                <a:off x="1896508" y="2186590"/>
                <a:ext cx="328582" cy="619035"/>
              </a:xfrm>
              <a:prstGeom prst="rect">
                <a:avLst/>
              </a:prstGeom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F37CF64-7CC2-BEF3-2324-E38782267C8A}"/>
                </a:ext>
              </a:extLst>
            </p:cNvPr>
            <p:cNvSpPr txBox="1"/>
            <p:nvPr/>
          </p:nvSpPr>
          <p:spPr>
            <a:xfrm rot="16200000">
              <a:off x="2322621" y="2018566"/>
              <a:ext cx="523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P4 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ADAB5430-FB45-145C-61BE-B019F0BE173B}"/>
              </a:ext>
            </a:extLst>
          </p:cNvPr>
          <p:cNvGrpSpPr/>
          <p:nvPr/>
        </p:nvGrpSpPr>
        <p:grpSpPr>
          <a:xfrm>
            <a:off x="787806" y="2115645"/>
            <a:ext cx="2884197" cy="1211397"/>
            <a:chOff x="2010347" y="1657404"/>
            <a:chExt cx="2651785" cy="1100715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CF4B8AA-165F-DC03-60D6-B412C4ABA4DA}"/>
                </a:ext>
              </a:extLst>
            </p:cNvPr>
            <p:cNvSpPr txBox="1"/>
            <p:nvPr/>
          </p:nvSpPr>
          <p:spPr>
            <a:xfrm>
              <a:off x="4432582" y="2558064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C96E6CB-C0E8-41DF-E0C0-EBEDA6CC17BE}"/>
                </a:ext>
              </a:extLst>
            </p:cNvPr>
            <p:cNvSpPr txBox="1"/>
            <p:nvPr/>
          </p:nvSpPr>
          <p:spPr>
            <a:xfrm>
              <a:off x="4190102" y="2017382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B2F3B75-8A8B-2CCF-AE1C-514FDC135101}"/>
                </a:ext>
              </a:extLst>
            </p:cNvPr>
            <p:cNvSpPr txBox="1"/>
            <p:nvPr/>
          </p:nvSpPr>
          <p:spPr>
            <a:xfrm>
              <a:off x="3875410" y="1817327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455FED6-5F37-FE29-5A45-E95F69BEFAF6}"/>
                </a:ext>
              </a:extLst>
            </p:cNvPr>
            <p:cNvSpPr txBox="1"/>
            <p:nvPr/>
          </p:nvSpPr>
          <p:spPr>
            <a:xfrm>
              <a:off x="3607837" y="1657404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75E55B7-A1D1-EF90-319B-3D5599FD9638}"/>
                </a:ext>
              </a:extLst>
            </p:cNvPr>
            <p:cNvSpPr txBox="1"/>
            <p:nvPr/>
          </p:nvSpPr>
          <p:spPr>
            <a:xfrm>
              <a:off x="3314221" y="2504803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E9D7054-BA1E-1643-6565-A6FA8818FA45}"/>
                </a:ext>
              </a:extLst>
            </p:cNvPr>
            <p:cNvSpPr txBox="1"/>
            <p:nvPr/>
          </p:nvSpPr>
          <p:spPr>
            <a:xfrm>
              <a:off x="3046061" y="2201253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0DD5986-3355-BDCC-E0A8-DD22F4AD6736}"/>
                </a:ext>
              </a:extLst>
            </p:cNvPr>
            <p:cNvSpPr txBox="1"/>
            <p:nvPr/>
          </p:nvSpPr>
          <p:spPr>
            <a:xfrm>
              <a:off x="2792235" y="1762861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ACB2AF0-72AE-B15B-937F-2C0AEC111AA0}"/>
                </a:ext>
              </a:extLst>
            </p:cNvPr>
            <p:cNvSpPr txBox="1"/>
            <p:nvPr/>
          </p:nvSpPr>
          <p:spPr>
            <a:xfrm>
              <a:off x="2500150" y="2191614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79DCF87-C6DA-0982-6C90-E9DB13A526AB}"/>
                </a:ext>
              </a:extLst>
            </p:cNvPr>
            <p:cNvSpPr txBox="1"/>
            <p:nvPr/>
          </p:nvSpPr>
          <p:spPr>
            <a:xfrm>
              <a:off x="2270027" y="187532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3DE706E-6C36-3846-A36B-9CA2C3DF00DB}"/>
                </a:ext>
              </a:extLst>
            </p:cNvPr>
            <p:cNvSpPr txBox="1"/>
            <p:nvPr/>
          </p:nvSpPr>
          <p:spPr>
            <a:xfrm>
              <a:off x="2010347" y="2539359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45877A55-C334-DDF7-11CC-696A6544B6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45476" y="1740948"/>
            <a:ext cx="2269421" cy="1527495"/>
          </a:xfrm>
          <a:prstGeom prst="rect">
            <a:avLst/>
          </a:prstGeom>
        </p:spPr>
      </p:pic>
      <p:grpSp>
        <p:nvGrpSpPr>
          <p:cNvPr id="40" name="Group 39">
            <a:extLst>
              <a:ext uri="{FF2B5EF4-FFF2-40B4-BE49-F238E27FC236}">
                <a16:creationId xmlns:a16="http://schemas.microsoft.com/office/drawing/2014/main" id="{8998778E-F8E2-2D3A-8ACC-678E6893E7D8}"/>
              </a:ext>
            </a:extLst>
          </p:cNvPr>
          <p:cNvGrpSpPr/>
          <p:nvPr/>
        </p:nvGrpSpPr>
        <p:grpSpPr>
          <a:xfrm>
            <a:off x="3975680" y="-80474"/>
            <a:ext cx="2499440" cy="1567714"/>
            <a:chOff x="4056438" y="2198169"/>
            <a:chExt cx="2499440" cy="1567714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B1D94F69-4BDD-1E86-8CDF-4F6A879B0D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5267" t="45959" r="49479" b="41594"/>
            <a:stretch/>
          </p:blipFill>
          <p:spPr bwMode="auto">
            <a:xfrm>
              <a:off x="4056438" y="3072669"/>
              <a:ext cx="2499440" cy="693214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DFAD479-92C9-3723-C36B-F4B0A018D13B}"/>
                </a:ext>
              </a:extLst>
            </p:cNvPr>
            <p:cNvSpPr txBox="1"/>
            <p:nvPr/>
          </p:nvSpPr>
          <p:spPr>
            <a:xfrm rot="16200000">
              <a:off x="4577288" y="2623109"/>
              <a:ext cx="1065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NO 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9F531AA-99DE-BAD3-A712-AB19978D64C0}"/>
                </a:ext>
              </a:extLst>
            </p:cNvPr>
            <p:cNvSpPr txBox="1"/>
            <p:nvPr/>
          </p:nvSpPr>
          <p:spPr>
            <a:xfrm rot="16200000">
              <a:off x="5059227" y="2623108"/>
              <a:ext cx="1065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P2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04AD235-1F76-498F-CE15-82A3958FCFDC}"/>
                </a:ext>
              </a:extLst>
            </p:cNvPr>
            <p:cNvSpPr txBox="1"/>
            <p:nvPr/>
          </p:nvSpPr>
          <p:spPr>
            <a:xfrm rot="16200000">
              <a:off x="4095347" y="2623110"/>
              <a:ext cx="1065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P2 RLE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53AE6ECB-C841-E851-69B4-787467C01117}"/>
              </a:ext>
            </a:extLst>
          </p:cNvPr>
          <p:cNvSpPr txBox="1"/>
          <p:nvPr/>
        </p:nvSpPr>
        <p:spPr>
          <a:xfrm>
            <a:off x="118635" y="574098"/>
            <a:ext cx="45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A6C1DB3-01B6-DBAA-256E-9B3DB6730208}"/>
              </a:ext>
            </a:extLst>
          </p:cNvPr>
          <p:cNvSpPr txBox="1"/>
          <p:nvPr/>
        </p:nvSpPr>
        <p:spPr>
          <a:xfrm>
            <a:off x="3906822" y="599722"/>
            <a:ext cx="45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09E5A39-3021-F614-2476-A60CB42C9B12}"/>
              </a:ext>
            </a:extLst>
          </p:cNvPr>
          <p:cNvSpPr txBox="1"/>
          <p:nvPr/>
        </p:nvSpPr>
        <p:spPr>
          <a:xfrm>
            <a:off x="107769" y="1916550"/>
            <a:ext cx="45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4CC4782-445A-9423-D364-F3EF9B8D1CC0}"/>
              </a:ext>
            </a:extLst>
          </p:cNvPr>
          <p:cNvSpPr txBox="1"/>
          <p:nvPr/>
        </p:nvSpPr>
        <p:spPr>
          <a:xfrm>
            <a:off x="3939078" y="1916550"/>
            <a:ext cx="45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5E3114A-17B1-AE52-973D-B962899311AD}"/>
              </a:ext>
            </a:extLst>
          </p:cNvPr>
          <p:cNvSpPr txBox="1"/>
          <p:nvPr/>
        </p:nvSpPr>
        <p:spPr>
          <a:xfrm>
            <a:off x="139377" y="3892185"/>
            <a:ext cx="45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F80E24B8-1901-5956-CB07-6AD88A1208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377" y="5227042"/>
            <a:ext cx="6623265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- </a:t>
            </a:r>
            <a:r>
              <a:rPr lang="en-US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stern Blot analysis of  CHIKV nsP2  and its deletion mutants (A) Detection of </a:t>
            </a:r>
            <a:r>
              <a:rPr lang="en-US" alt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Ps</a:t>
            </a:r>
            <a:r>
              <a:rPr lang="en-US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IN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P1(~56kDa), nsP2(~89kDa), nsP3(~73kDa), nsP4(~68kDa) (B) Detection of nsP2 and </a:t>
            </a:r>
            <a:r>
              <a:rPr lang="en-IN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Loop</a:t>
            </a:r>
            <a:r>
              <a:rPr lang="en-IN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sP2 RLE mutant(~89kDa)  (C) Detection of nsP2 deletion mutants-</a:t>
            </a:r>
            <a:r>
              <a:rPr lang="en-US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P2(89kDa), NTD(18kDa), H(34kDa), NH(56kDa), HP(48kDa), NHP(65kDa), HPM(70kDa), P(17kDa), PM(37kDa), M(22kDa) (D)Detection of N-terminal deletion mutants- NH (56kDa), </a:t>
            </a:r>
            <a:r>
              <a:rPr lang="en-US" alt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14 NH(~52kDa), Δ77 NH(~51kDa), and Δ110 NH</a:t>
            </a:r>
            <a:r>
              <a:rPr lang="en-US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(~44kDa) (E) Detection of nsP2(~89kDa), and helicase mutants -K192A, D252A, and DE252/253AA (~89kDa).</a:t>
            </a:r>
            <a:endParaRPr lang="en-US" sz="1000" dirty="0"/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DFF1B59C-0DDA-C4C8-3FD9-75CC55DE6409}"/>
              </a:ext>
            </a:extLst>
          </p:cNvPr>
          <p:cNvGrpSpPr/>
          <p:nvPr/>
        </p:nvGrpSpPr>
        <p:grpSpPr>
          <a:xfrm>
            <a:off x="443103" y="3148726"/>
            <a:ext cx="2868652" cy="1753375"/>
            <a:chOff x="510777" y="3011562"/>
            <a:chExt cx="2868652" cy="1753375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3EB6023D-0277-089C-8503-1A7040C76335}"/>
                </a:ext>
              </a:extLst>
            </p:cNvPr>
            <p:cNvGrpSpPr/>
            <p:nvPr/>
          </p:nvGrpSpPr>
          <p:grpSpPr>
            <a:xfrm>
              <a:off x="548305" y="3011562"/>
              <a:ext cx="2831124" cy="1753375"/>
              <a:chOff x="8077201" y="3246713"/>
              <a:chExt cx="2831124" cy="1753375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87303A18-E897-8AA5-D994-5A913B5C22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21" t="35921" r="47710" b="51340"/>
              <a:stretch/>
            </p:blipFill>
            <p:spPr>
              <a:xfrm>
                <a:off x="8077201" y="4261321"/>
                <a:ext cx="2377124" cy="738767"/>
              </a:xfrm>
              <a:prstGeom prst="rect">
                <a:avLst/>
              </a:prstGeom>
            </p:spPr>
          </p:pic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0F0510ED-5639-BD50-9E19-9DFFC1F31445}"/>
                  </a:ext>
                </a:extLst>
              </p:cNvPr>
              <p:cNvSpPr/>
              <p:nvPr/>
            </p:nvSpPr>
            <p:spPr>
              <a:xfrm>
                <a:off x="10354143" y="4433291"/>
                <a:ext cx="554182" cy="3693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00</a:t>
                </a:r>
              </a:p>
              <a:p>
                <a:endPara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-75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8C87AD5-5914-F7F0-30AE-29D64DBC4D00}"/>
                  </a:ext>
                </a:extLst>
              </p:cNvPr>
              <p:cNvSpPr txBox="1"/>
              <p:nvPr/>
            </p:nvSpPr>
            <p:spPr>
              <a:xfrm rot="16200000">
                <a:off x="9684913" y="3680619"/>
                <a:ext cx="10653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UNO </a:t>
                </a:r>
                <a:endParaRPr lang="en-IN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8452185-EE62-11F4-C7B9-B73BF5D89D51}"/>
                  </a:ext>
                </a:extLst>
              </p:cNvPr>
              <p:cNvSpPr txBox="1"/>
              <p:nvPr/>
            </p:nvSpPr>
            <p:spPr>
              <a:xfrm rot="16200000">
                <a:off x="9003594" y="3689581"/>
                <a:ext cx="10653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P2</a:t>
                </a:r>
                <a:endParaRPr lang="en-IN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173EC986-6D68-FA0C-7C02-312408F4B14C}"/>
                  </a:ext>
                </a:extLst>
              </p:cNvPr>
              <p:cNvSpPr txBox="1"/>
              <p:nvPr/>
            </p:nvSpPr>
            <p:spPr>
              <a:xfrm rot="16200000">
                <a:off x="7739570" y="3698547"/>
                <a:ext cx="10653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192A</a:t>
                </a:r>
                <a:endParaRPr lang="en-IN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ECC27BD-3338-2239-3BD1-8E8E58ACC33B}"/>
                  </a:ext>
                </a:extLst>
              </p:cNvPr>
              <p:cNvSpPr txBox="1"/>
              <p:nvPr/>
            </p:nvSpPr>
            <p:spPr>
              <a:xfrm rot="16200000">
                <a:off x="8089192" y="3671652"/>
                <a:ext cx="10653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252A</a:t>
                </a:r>
                <a:endParaRPr lang="en-IN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E922635-3871-1C80-C72E-E6026B6BB176}"/>
                  </a:ext>
                </a:extLst>
              </p:cNvPr>
              <p:cNvSpPr txBox="1"/>
              <p:nvPr/>
            </p:nvSpPr>
            <p:spPr>
              <a:xfrm rot="16200000">
                <a:off x="8555359" y="3691199"/>
                <a:ext cx="10653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252/253AA</a:t>
                </a:r>
                <a:endParaRPr lang="en-IN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4266140-CF48-F55E-E717-1DD63F06FCD4}"/>
                </a:ext>
              </a:extLst>
            </p:cNvPr>
            <p:cNvSpPr txBox="1"/>
            <p:nvPr/>
          </p:nvSpPr>
          <p:spPr>
            <a:xfrm>
              <a:off x="510777" y="4305916"/>
              <a:ext cx="249669" cy="220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7A46BB4-8C20-4D1D-B939-457FCE384C35}"/>
                </a:ext>
              </a:extLst>
            </p:cNvPr>
            <p:cNvSpPr txBox="1"/>
            <p:nvPr/>
          </p:nvSpPr>
          <p:spPr>
            <a:xfrm>
              <a:off x="860954" y="4320928"/>
              <a:ext cx="249669" cy="220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C6FA5CC-FCF3-708E-68E7-6B76BA3EF32D}"/>
                </a:ext>
              </a:extLst>
            </p:cNvPr>
            <p:cNvSpPr txBox="1"/>
            <p:nvPr/>
          </p:nvSpPr>
          <p:spPr>
            <a:xfrm>
              <a:off x="1247580" y="4335652"/>
              <a:ext cx="249669" cy="220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DA41CAB-07F0-5103-7D05-3777B949A509}"/>
                </a:ext>
              </a:extLst>
            </p:cNvPr>
            <p:cNvSpPr txBox="1"/>
            <p:nvPr/>
          </p:nvSpPr>
          <p:spPr>
            <a:xfrm>
              <a:off x="1702198" y="4303613"/>
              <a:ext cx="249669" cy="220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0000"/>
                  </a:solidFill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60909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220</TotalTime>
  <Words>187</Words>
  <Application>Microsoft Macintosh PowerPoint</Application>
  <PresentationFormat>A4 Paper (210x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15</cp:revision>
  <dcterms:created xsi:type="dcterms:W3CDTF">2025-04-23T11:11:25Z</dcterms:created>
  <dcterms:modified xsi:type="dcterms:W3CDTF">2025-07-03T17:56:10Z</dcterms:modified>
</cp:coreProperties>
</file>